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0A57B4-6C98-4D16-BCB3-45F9B71190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AE70D5-AC84-4243-8304-67A5CD368A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0D4371-9BAE-41E8-8438-5494C93E03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F75286-F251-46D5-831A-FCE9B2C4890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BA2430-680C-4E58-AB21-4AAE8562AA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0D31BF-60B0-4A22-9B9C-F3DE9A1C73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01FC6-9C48-420E-9760-AC292F242D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4E5553-7FB9-4668-A51E-915A53F422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BE2593-19E8-4C90-BF19-A85AD06B01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89E99D-3AA2-4F18-8153-7799179C14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04C6DD-37EE-4FDE-B035-500A78DAEE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E62370-CBB5-48CF-B91D-1DDB61B107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DF816E-488B-448D-84FA-43DB346C5F7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84040" y="6062760"/>
            <a:ext cx="62262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13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omparison of chromatin modifications [7], binding of transcription factors [9, 16, 17], and binding motifs among responsive and non-responsive genes with no CpG islands; “n/s” = non-significa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624640" y="998640"/>
            <a:ext cx="0" cy="3429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33520" y="3421080"/>
            <a:ext cx="6019560" cy="1006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309840" y="3422520"/>
            <a:ext cx="0" cy="1005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462640" y="3422520"/>
            <a:ext cx="0" cy="1005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-597960" y="2383200"/>
            <a:ext cx="151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oportion of 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139760" y="998640"/>
            <a:ext cx="0" cy="3429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567880" y="1328760"/>
            <a:ext cx="1166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inding of TF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5556240" y="1295280"/>
            <a:ext cx="1073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F binding motif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16200000">
            <a:off x="376200" y="1448640"/>
            <a:ext cx="958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hroma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38200" y="998640"/>
            <a:ext cx="6014880" cy="2422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6200000">
            <a:off x="5290920" y="3934080"/>
            <a:ext cx="527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&lt;1 K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321000" y="4154400"/>
            <a:ext cx="1936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3 to 15 Kb from TS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219320" y="4149720"/>
            <a:ext cx="175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0.3 Kb from TS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539640" y="1324080"/>
            <a:ext cx="0" cy="209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rot="16200000">
            <a:off x="767880" y="3015000"/>
            <a:ext cx="31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/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16200000">
            <a:off x="1848960" y="3160440"/>
            <a:ext cx="31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/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rot="16200000">
            <a:off x="3130560" y="742680"/>
            <a:ext cx="811800" cy="6089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3K4me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3K27me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3K36me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3K9me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dx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u5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x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ano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at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ma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Klf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f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2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y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yc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srr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cfcp2l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c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dx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u5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x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ano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at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ma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Klf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f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2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y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yc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srr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cfcp2l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c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rg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A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R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Y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T00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T00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1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A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9" name=""/>
          <p:cNvGrpSpPr/>
          <p:nvPr/>
        </p:nvGrpSpPr>
        <p:grpSpPr>
          <a:xfrm>
            <a:off x="4038480" y="1166760"/>
            <a:ext cx="1393920" cy="509400"/>
            <a:chOff x="4038480" y="1166760"/>
            <a:chExt cx="1393920" cy="509400"/>
          </a:xfrm>
        </p:grpSpPr>
        <p:sp>
          <p:nvSpPr>
            <p:cNvPr id="60" name=""/>
            <p:cNvSpPr/>
            <p:nvPr/>
          </p:nvSpPr>
          <p:spPr>
            <a:xfrm>
              <a:off x="4038480" y="1166760"/>
              <a:ext cx="1393920" cy="5094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213080" y="1314360"/>
              <a:ext cx="799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Responsiv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216320" y="1479240"/>
              <a:ext cx="1170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n-responsiv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4203360" y="1169640"/>
              <a:ext cx="494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Genes: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089240" y="1369800"/>
              <a:ext cx="79560" cy="85680"/>
            </a:xfrm>
            <a:prstGeom prst="rect">
              <a:avLst/>
            </a:prstGeom>
            <a:solidFill>
              <a:srgbClr val="ff00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089240" y="1547640"/>
              <a:ext cx="79560" cy="84240"/>
            </a:xfrm>
            <a:prstGeom prst="rect">
              <a:avLst/>
            </a:prstGeom>
            <a:solidFill>
              <a:srgbClr val="333399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"/>
          <p:cNvSpPr/>
          <p:nvPr/>
        </p:nvSpPr>
        <p:spPr>
          <a:xfrm rot="16200000">
            <a:off x="1058400" y="3122280"/>
            <a:ext cx="31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/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rot="16200000">
            <a:off x="1211040" y="3132000"/>
            <a:ext cx="31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/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rot="16200000">
            <a:off x="1363320" y="3146760"/>
            <a:ext cx="31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/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rot="16200000">
            <a:off x="1515600" y="3151080"/>
            <a:ext cx="31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/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rot="16200000">
            <a:off x="2439720" y="3124080"/>
            <a:ext cx="31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/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16200000">
            <a:off x="2620800" y="3100680"/>
            <a:ext cx="31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/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rot="16200000">
            <a:off x="3072960" y="3071520"/>
            <a:ext cx="31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/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6200000">
            <a:off x="3211200" y="2757240"/>
            <a:ext cx="31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/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rot="16200000">
            <a:off x="6292440" y="2447640"/>
            <a:ext cx="31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/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rot="16200000">
            <a:off x="5806800" y="2885760"/>
            <a:ext cx="31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/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rot="16200000">
            <a:off x="5678280" y="3084840"/>
            <a:ext cx="31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/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rot="16200000">
            <a:off x="5987880" y="2869920"/>
            <a:ext cx="31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/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8" name=""/>
          <p:cNvGrpSpPr/>
          <p:nvPr/>
        </p:nvGrpSpPr>
        <p:grpSpPr>
          <a:xfrm>
            <a:off x="561960" y="2100240"/>
            <a:ext cx="5954760" cy="1325520"/>
            <a:chOff x="561960" y="2100240"/>
            <a:chExt cx="5954760" cy="1325520"/>
          </a:xfrm>
        </p:grpSpPr>
        <p:sp>
          <p:nvSpPr>
            <p:cNvPr id="79" name=""/>
            <p:cNvSpPr/>
            <p:nvPr/>
          </p:nvSpPr>
          <p:spPr>
            <a:xfrm>
              <a:off x="561960" y="2700360"/>
              <a:ext cx="44280" cy="72540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718920" y="3306600"/>
              <a:ext cx="44640" cy="11916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868320" y="3289320"/>
              <a:ext cx="46080" cy="13644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1027080" y="3317760"/>
              <a:ext cx="44280" cy="10800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333440" y="3402000"/>
              <a:ext cx="44640" cy="2376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490760" y="3413160"/>
              <a:ext cx="44280" cy="1260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639800" y="3406680"/>
              <a:ext cx="46080" cy="1908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798560" y="3402000"/>
              <a:ext cx="44640" cy="2376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104920" y="3330720"/>
              <a:ext cx="44640" cy="9504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254320" y="3324240"/>
              <a:ext cx="46080" cy="10152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411280" y="3265560"/>
              <a:ext cx="46080" cy="16020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570040" y="3382920"/>
              <a:ext cx="44640" cy="4284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719440" y="3359160"/>
              <a:ext cx="44280" cy="6660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876400" y="3348000"/>
              <a:ext cx="44640" cy="7776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025800" y="3313080"/>
              <a:ext cx="46080" cy="11268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184560" y="3389400"/>
              <a:ext cx="44280" cy="3636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341520" y="3068640"/>
              <a:ext cx="44640" cy="35712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490920" y="3222720"/>
              <a:ext cx="44280" cy="20304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647880" y="3187800"/>
              <a:ext cx="44640" cy="23796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797280" y="3009960"/>
              <a:ext cx="46080" cy="41580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956040" y="3235320"/>
              <a:ext cx="44280" cy="19044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4113000" y="3341520"/>
              <a:ext cx="44640" cy="8424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262400" y="2832120"/>
              <a:ext cx="44280" cy="59364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4419720" y="2921040"/>
              <a:ext cx="44280" cy="50472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568760" y="2730600"/>
              <a:ext cx="46080" cy="69516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4727520" y="3265560"/>
              <a:ext cx="44640" cy="16020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4884840" y="3116160"/>
              <a:ext cx="44280" cy="30960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5033880" y="2529000"/>
              <a:ext cx="44640" cy="89676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5191200" y="2433600"/>
              <a:ext cx="44280" cy="99216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5342040" y="2130480"/>
              <a:ext cx="44280" cy="129528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5499000" y="3348000"/>
              <a:ext cx="44640" cy="7776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5648400" y="2944800"/>
              <a:ext cx="44280" cy="48096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5805360" y="3382920"/>
              <a:ext cx="44640" cy="4284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5962680" y="3170160"/>
              <a:ext cx="44280" cy="25560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6113520" y="3152880"/>
              <a:ext cx="44280" cy="27288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6270480" y="3395520"/>
              <a:ext cx="44640" cy="3024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6419880" y="2771640"/>
              <a:ext cx="44280" cy="654120"/>
            </a:xfrm>
            <a:prstGeom prst="rect">
              <a:avLst/>
            </a:prstGeom>
            <a:solidFill>
              <a:srgbClr val="ff00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606240" y="3176640"/>
              <a:ext cx="46080" cy="24912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763560" y="3359160"/>
              <a:ext cx="38160" cy="6660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914400" y="3294000"/>
              <a:ext cx="44280" cy="13176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071360" y="3382920"/>
              <a:ext cx="36720" cy="4284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1220760" y="3419640"/>
              <a:ext cx="46080" cy="612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378080" y="3413160"/>
              <a:ext cx="45720" cy="1260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535040" y="3419640"/>
              <a:ext cx="38160" cy="612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1685880" y="3402000"/>
              <a:ext cx="44280" cy="2376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1843200" y="3413160"/>
              <a:ext cx="36360" cy="1260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2149560" y="3365640"/>
              <a:ext cx="37800" cy="6012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2300400" y="3365640"/>
              <a:ext cx="44280" cy="6012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2457360" y="3313080"/>
              <a:ext cx="44640" cy="11268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2614680" y="3395520"/>
              <a:ext cx="36360" cy="3024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2763720" y="3365640"/>
              <a:ext cx="46080" cy="6012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2921040" y="3389400"/>
              <a:ext cx="38160" cy="3636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3071880" y="3359160"/>
              <a:ext cx="44280" cy="6660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3228840" y="3382920"/>
              <a:ext cx="44640" cy="4284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3386160" y="3110040"/>
              <a:ext cx="38160" cy="31572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3535200" y="3341520"/>
              <a:ext cx="46080" cy="8424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3692520" y="3306600"/>
              <a:ext cx="38160" cy="11916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3843360" y="3211560"/>
              <a:ext cx="44280" cy="21420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000320" y="3359160"/>
              <a:ext cx="44640" cy="6660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4157640" y="3406680"/>
              <a:ext cx="38160" cy="1908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4306680" y="3129120"/>
              <a:ext cx="46080" cy="29664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4464000" y="3116160"/>
              <a:ext cx="38160" cy="30960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4614840" y="3003480"/>
              <a:ext cx="44280" cy="42228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4772160" y="3317760"/>
              <a:ext cx="44280" cy="10800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4929120" y="3211560"/>
              <a:ext cx="38160" cy="21420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5078520" y="2901960"/>
              <a:ext cx="45720" cy="52380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5235480" y="2789280"/>
              <a:ext cx="38160" cy="63648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5386320" y="2427120"/>
              <a:ext cx="44640" cy="99864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5543640" y="3378240"/>
              <a:ext cx="37800" cy="4752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5692680" y="3068640"/>
              <a:ext cx="46080" cy="35712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5850000" y="3389400"/>
              <a:ext cx="46080" cy="3636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6006960" y="3181320"/>
              <a:ext cx="38160" cy="24444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6157800" y="3152880"/>
              <a:ext cx="44640" cy="27288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6315120" y="3406680"/>
              <a:ext cx="38160" cy="1908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6464160" y="2730600"/>
              <a:ext cx="46080" cy="695160"/>
            </a:xfrm>
            <a:prstGeom prst="rect">
              <a:avLst/>
            </a:prstGeom>
            <a:solidFill>
              <a:srgbClr val="333399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584280" y="2676600"/>
              <a:ext cx="0" cy="23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561960" y="267660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flipV="1">
              <a:off x="741240" y="3293640"/>
              <a:ext cx="0" cy="126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718920" y="329400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 flipV="1">
              <a:off x="892080" y="3269880"/>
              <a:ext cx="0" cy="190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868320" y="327024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 flipV="1">
              <a:off x="1049400" y="3306240"/>
              <a:ext cx="0" cy="11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1027080" y="330660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 flipV="1">
              <a:off x="1198440" y="3419280"/>
              <a:ext cx="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1176120" y="341964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 flipV="1">
              <a:off x="1355760" y="3395520"/>
              <a:ext cx="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1333440" y="339552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 flipV="1">
              <a:off x="1512720" y="3406680"/>
              <a:ext cx="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1490760" y="340668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 flipV="1">
              <a:off x="1663560" y="3401640"/>
              <a:ext cx="0" cy="46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1639800" y="340200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 flipV="1">
              <a:off x="1820880" y="3395520"/>
              <a:ext cx="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1798560" y="339552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1969920" y="34257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1947960" y="342576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 flipV="1">
              <a:off x="2127240" y="3317760"/>
              <a:ext cx="0" cy="129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2104920" y="331776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 flipV="1">
              <a:off x="2278080" y="3312720"/>
              <a:ext cx="0" cy="11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2254320" y="331308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 flipV="1">
              <a:off x="2435040" y="3246120"/>
              <a:ext cx="0" cy="190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2411280" y="3246480"/>
              <a:ext cx="540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 flipV="1">
              <a:off x="2592360" y="3377880"/>
              <a:ext cx="0" cy="46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2570040" y="337824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 flipV="1">
              <a:off x="2741400" y="3347640"/>
              <a:ext cx="0" cy="11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2719440" y="334800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 flipV="1">
              <a:off x="2898720" y="3341520"/>
              <a:ext cx="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2876400" y="334152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 flipV="1">
              <a:off x="3049560" y="3300120"/>
              <a:ext cx="0" cy="126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3025800" y="330048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 flipV="1">
              <a:off x="3206880" y="3377880"/>
              <a:ext cx="0" cy="11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3184560" y="337824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 flipV="1">
              <a:off x="3363840" y="3050640"/>
              <a:ext cx="0" cy="176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3341520" y="305100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 flipV="1">
              <a:off x="3513240" y="3211200"/>
              <a:ext cx="0" cy="11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3490920" y="321156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 flipV="1">
              <a:off x="3670200" y="3169800"/>
              <a:ext cx="0" cy="176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3647880" y="317016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 flipV="1">
              <a:off x="3821040" y="2986200"/>
              <a:ext cx="0" cy="23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3797280" y="298620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 flipV="1">
              <a:off x="3978360" y="3222360"/>
              <a:ext cx="0" cy="126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3956040" y="322272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 flipV="1">
              <a:off x="4135320" y="3336480"/>
              <a:ext cx="0" cy="46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4113000" y="333684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 flipV="1">
              <a:off x="4284720" y="2812680"/>
              <a:ext cx="0" cy="190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4262400" y="281304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 flipV="1">
              <a:off x="4441680" y="2897280"/>
              <a:ext cx="0" cy="23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4419720" y="289728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 flipV="1">
              <a:off x="4592520" y="2706840"/>
              <a:ext cx="0" cy="23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4568760" y="2706840"/>
              <a:ext cx="540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 flipV="1">
              <a:off x="4749840" y="3246120"/>
              <a:ext cx="0" cy="190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4727520" y="324648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 flipV="1">
              <a:off x="4906800" y="3104640"/>
              <a:ext cx="0" cy="11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4884840" y="310500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 flipV="1">
              <a:off x="5056200" y="2498760"/>
              <a:ext cx="0" cy="302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5033880" y="249876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 flipV="1">
              <a:off x="5213160" y="2403360"/>
              <a:ext cx="0" cy="302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5191200" y="240336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 flipV="1">
              <a:off x="5364000" y="2100240"/>
              <a:ext cx="0" cy="302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5342040" y="210024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 flipV="1">
              <a:off x="5521320" y="3336480"/>
              <a:ext cx="0" cy="11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5499000" y="333684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 flipV="1">
              <a:off x="5670360" y="2921040"/>
              <a:ext cx="0" cy="23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5648400" y="292104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 flipV="1">
              <a:off x="5827680" y="3377880"/>
              <a:ext cx="0" cy="46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5805360" y="337824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 flipV="1">
              <a:off x="5985000" y="3152880"/>
              <a:ext cx="0" cy="172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5962680" y="315288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 flipV="1">
              <a:off x="6135480" y="3133440"/>
              <a:ext cx="0" cy="190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6113520" y="313380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 flipV="1">
              <a:off x="6292800" y="3389040"/>
              <a:ext cx="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6270480" y="338940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 flipV="1">
              <a:off x="6442200" y="2747880"/>
              <a:ext cx="0" cy="23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6419880" y="274788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 flipV="1">
              <a:off x="628560" y="3157200"/>
              <a:ext cx="0" cy="190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606240" y="315756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 flipV="1">
              <a:off x="779400" y="3347640"/>
              <a:ext cx="0" cy="11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757080" y="334800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 flipV="1">
              <a:off x="936720" y="3282480"/>
              <a:ext cx="0" cy="11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914400" y="328284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 flipV="1">
              <a:off x="1085760" y="3377880"/>
              <a:ext cx="0" cy="46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1063440" y="337824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 flipV="1">
              <a:off x="1243080" y="3413160"/>
              <a:ext cx="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1220760" y="341316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 flipV="1">
              <a:off x="1400040" y="3406680"/>
              <a:ext cx="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1378080" y="340668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 flipV="1">
              <a:off x="1550880" y="3413160"/>
              <a:ext cx="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1528560" y="341316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flipV="1">
              <a:off x="1708200" y="3395520"/>
              <a:ext cx="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1685880" y="339552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1857240" y="34131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1835280" y="341316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2014560" y="34257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1992240" y="342576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 flipV="1">
              <a:off x="2165400" y="3359160"/>
              <a:ext cx="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2143080" y="335916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 flipV="1">
              <a:off x="2322360" y="3359160"/>
              <a:ext cx="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2300400" y="335916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 flipV="1">
              <a:off x="2479680" y="3300120"/>
              <a:ext cx="0" cy="126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2457360" y="330048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 flipV="1">
              <a:off x="2628720" y="3389040"/>
              <a:ext cx="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2606760" y="338940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 flipV="1">
              <a:off x="2786040" y="3359160"/>
              <a:ext cx="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2763720" y="335916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 flipV="1">
              <a:off x="2936880" y="3382920"/>
              <a:ext cx="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2914560" y="338292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 flipV="1">
              <a:off x="3093840" y="3354120"/>
              <a:ext cx="0" cy="46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3071880" y="335448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 flipV="1">
              <a:off x="3251160" y="3377880"/>
              <a:ext cx="0" cy="46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3228840" y="337824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 flipV="1">
              <a:off x="3400560" y="3092040"/>
              <a:ext cx="0" cy="176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3378240" y="309240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 flipV="1">
              <a:off x="3557520" y="3330720"/>
              <a:ext cx="0" cy="10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3535200" y="333072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 flipV="1">
              <a:off x="3708360" y="3293640"/>
              <a:ext cx="0" cy="126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3686040" y="329400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 flipV="1">
              <a:off x="3865680" y="3198600"/>
              <a:ext cx="0" cy="126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3843360" y="319896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 flipV="1">
              <a:off x="4022640" y="3347640"/>
              <a:ext cx="0" cy="11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4000320" y="334800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 flipV="1">
              <a:off x="4172040" y="3401640"/>
              <a:ext cx="0" cy="46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4149720" y="340200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 flipV="1">
              <a:off x="4329000" y="3109680"/>
              <a:ext cx="0" cy="190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4306680" y="311004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 flipV="1">
              <a:off x="4479840" y="3104640"/>
              <a:ext cx="0" cy="11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4457520" y="310500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 flipV="1">
              <a:off x="4637160" y="2986200"/>
              <a:ext cx="0" cy="172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4614840" y="298620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 flipV="1">
              <a:off x="4794120" y="3306240"/>
              <a:ext cx="0" cy="11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4772160" y="330660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 flipV="1">
              <a:off x="4943520" y="3198600"/>
              <a:ext cx="0" cy="126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4921200" y="319896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 flipV="1">
              <a:off x="5102280" y="2883960"/>
              <a:ext cx="0" cy="176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5078520" y="288432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 flipV="1">
              <a:off x="5251320" y="2765520"/>
              <a:ext cx="0" cy="23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5229360" y="276552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 flipV="1">
              <a:off x="5408640" y="2403360"/>
              <a:ext cx="0" cy="23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5386320" y="240336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 flipV="1">
              <a:off x="5557680" y="3371760"/>
              <a:ext cx="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5535720" y="337176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 flipV="1">
              <a:off x="5715000" y="3057120"/>
              <a:ext cx="0" cy="11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5692680" y="305748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5873760" y="33894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5850000" y="338940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 flipV="1">
              <a:off x="6022800" y="3169800"/>
              <a:ext cx="0" cy="11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6000840" y="317016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 flipV="1">
              <a:off x="6180120" y="3139920"/>
              <a:ext cx="0" cy="129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6157800" y="313992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6329160" y="3406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6307200" y="3406680"/>
              <a:ext cx="522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 flipV="1">
              <a:off x="6486480" y="2712600"/>
              <a:ext cx="0" cy="176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6464160" y="2712960"/>
              <a:ext cx="5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0" name=""/>
          <p:cNvSpPr/>
          <p:nvPr/>
        </p:nvSpPr>
        <p:spPr>
          <a:xfrm>
            <a:off x="503280" y="342108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503280" y="319248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503280" y="295740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503280" y="273060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503280" y="250200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503280" y="226836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503280" y="203976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503280" y="181296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503280" y="158436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503280" y="135108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503280" y="112248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375840" y="33656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278640" y="29019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278640" y="24447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278640" y="19843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278640" y="1528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375480" y="106668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28T20:23:48Z</dcterms:created>
  <dc:creator>Alexei Sharov</dc:creator>
  <dc:description/>
  <dc:language>en-US</dc:language>
  <cp:lastModifiedBy>Alexei Sharov</cp:lastModifiedBy>
  <dcterms:modified xsi:type="dcterms:W3CDTF">2011-01-28T20:33:35Z</dcterms:modified>
  <cp:revision>5</cp:revision>
  <dc:subject/>
  <dc:title>Slide 1</dc:title>
</cp:coreProperties>
</file>